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bdaelee\Documents\Manuscript\LRRK2%20RAB\Mol%20Neurodegener\1st%20revision\&#48373;&#49324;&#48376;%2020171228-plasma%20membrane%20fraction%20&#51221;&#4704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A9B-4A62-A478-1F9384083FA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A9B-4A62-A478-1F9384083FA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A9B-4A62-A478-1F9384083FA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18:$J$20</c:f>
                <c:numCache>
                  <c:formatCode>General</c:formatCode>
                  <c:ptCount val="3"/>
                  <c:pt idx="0">
                    <c:v>6.0284781377070107E-2</c:v>
                  </c:pt>
                  <c:pt idx="1">
                    <c:v>4.4182785187416279E-2</c:v>
                  </c:pt>
                  <c:pt idx="2">
                    <c:v>0.106523119646768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K$18:$K$20</c:f>
              <c:numCache>
                <c:formatCode>General</c:formatCode>
                <c:ptCount val="3"/>
              </c:numCache>
            </c:numRef>
          </c:cat>
          <c:val>
            <c:numRef>
              <c:f>Sheet1!$I$18:$I$20</c:f>
              <c:numCache>
                <c:formatCode>General</c:formatCode>
                <c:ptCount val="3"/>
                <c:pt idx="0">
                  <c:v>0.96819158259506022</c:v>
                </c:pt>
                <c:pt idx="1">
                  <c:v>0.74205194867551094</c:v>
                </c:pt>
                <c:pt idx="2">
                  <c:v>1.06871277597339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A9B-4A62-A478-1F9384083F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494737439"/>
        <c:axId val="1494733279"/>
      </c:barChart>
      <c:catAx>
        <c:axId val="14947374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494733279"/>
        <c:crosses val="autoZero"/>
        <c:auto val="1"/>
        <c:lblAlgn val="ctr"/>
        <c:lblOffset val="100"/>
        <c:noMultiLvlLbl val="0"/>
      </c:catAx>
      <c:valAx>
        <c:axId val="149473327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94737439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6837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5846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0866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3594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5936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7920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4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3414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5948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1606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390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7C4B2-38CE-49BF-8BBF-5FA2F7CCEE5E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850BC-C684-43DE-9F45-866DA2C4BE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5415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chart" Target="../charts/chart1.xm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/>
          <p:cNvSpPr txBox="1"/>
          <p:nvPr/>
        </p:nvSpPr>
        <p:spPr>
          <a:xfrm>
            <a:off x="2697437" y="1918684"/>
            <a:ext cx="56746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Total lysat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719656" y="1918684"/>
            <a:ext cx="51456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Membran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 rot="18849309">
            <a:off x="2671112" y="2186021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849309">
            <a:off x="2913158" y="2162334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8849309">
            <a:off x="3159585" y="2162334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8849309">
            <a:off x="2391824" y="2162444"/>
            <a:ext cx="4171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849309">
            <a:off x="3687544" y="2186021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8849309">
            <a:off x="3923240" y="2162334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8849309">
            <a:off x="4156967" y="2162334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8849309">
            <a:off x="3440006" y="2162444"/>
            <a:ext cx="4171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22"/>
          <p:cNvSpPr txBox="1"/>
          <p:nvPr/>
        </p:nvSpPr>
        <p:spPr>
          <a:xfrm>
            <a:off x="293232" y="1090706"/>
            <a:ext cx="6220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3. Localization of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b35 WT and phosphomutant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그룹 62"/>
          <p:cNvGrpSpPr/>
          <p:nvPr/>
        </p:nvGrpSpPr>
        <p:grpSpPr>
          <a:xfrm>
            <a:off x="1935920" y="2453476"/>
            <a:ext cx="2525132" cy="258286"/>
            <a:chOff x="1935920" y="2453476"/>
            <a:chExt cx="2525132" cy="258286"/>
          </a:xfrm>
        </p:grpSpPr>
        <p:sp>
          <p:nvSpPr>
            <p:cNvPr id="64" name="TextBox 63"/>
            <p:cNvSpPr txBox="1"/>
            <p:nvPr/>
          </p:nvSpPr>
          <p:spPr>
            <a:xfrm>
              <a:off x="1935920" y="2459509"/>
              <a:ext cx="376706" cy="24622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V5</a:t>
              </a:r>
            </a:p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(Rab35)</a:t>
              </a:r>
              <a:endParaRPr lang="en-US" sz="800" b="1" dirty="0">
                <a:latin typeface="Arial"/>
                <a:cs typeface="Arial"/>
              </a:endParaRPr>
            </a:p>
          </p:txBody>
        </p:sp>
        <p:pic>
          <p:nvPicPr>
            <p:cNvPr id="65" name="그림 6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95" t="11690" r="49482" b="80991"/>
            <a:stretch/>
          </p:blipFill>
          <p:spPr>
            <a:xfrm>
              <a:off x="2422017" y="2455155"/>
              <a:ext cx="2039035" cy="254929"/>
            </a:xfrm>
            <a:prstGeom prst="rect">
              <a:avLst/>
            </a:prstGeom>
          </p:spPr>
        </p:pic>
        <p:sp>
          <p:nvSpPr>
            <p:cNvPr id="66" name="Rectangle 12"/>
            <p:cNvSpPr/>
            <p:nvPr/>
          </p:nvSpPr>
          <p:spPr>
            <a:xfrm>
              <a:off x="2409413" y="2453476"/>
              <a:ext cx="2045673" cy="25828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grpSp>
        <p:nvGrpSpPr>
          <p:cNvPr id="67" name="그룹 66"/>
          <p:cNvGrpSpPr/>
          <p:nvPr/>
        </p:nvGrpSpPr>
        <p:grpSpPr>
          <a:xfrm>
            <a:off x="1793503" y="2765096"/>
            <a:ext cx="2659929" cy="262298"/>
            <a:chOff x="1793503" y="2761395"/>
            <a:chExt cx="2659929" cy="262298"/>
          </a:xfrm>
        </p:grpSpPr>
        <p:sp>
          <p:nvSpPr>
            <p:cNvPr id="68" name="TextBox 67"/>
            <p:cNvSpPr txBox="1"/>
            <p:nvPr/>
          </p:nvSpPr>
          <p:spPr>
            <a:xfrm>
              <a:off x="1793503" y="2830989"/>
              <a:ext cx="52097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Caveolin-1</a:t>
              </a:r>
              <a:endParaRPr lang="en-US" sz="800" b="1" dirty="0">
                <a:latin typeface="Arial"/>
                <a:cs typeface="Arial"/>
              </a:endParaRPr>
            </a:p>
          </p:txBody>
        </p:sp>
        <p:pic>
          <p:nvPicPr>
            <p:cNvPr id="69" name="그림 6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81" t="37496" r="25961" b="45897"/>
            <a:stretch/>
          </p:blipFill>
          <p:spPr>
            <a:xfrm>
              <a:off x="2414396" y="2761395"/>
              <a:ext cx="2039035" cy="262298"/>
            </a:xfrm>
            <a:prstGeom prst="rect">
              <a:avLst/>
            </a:prstGeom>
          </p:spPr>
        </p:pic>
        <p:sp>
          <p:nvSpPr>
            <p:cNvPr id="70" name="Rectangle 12"/>
            <p:cNvSpPr/>
            <p:nvPr/>
          </p:nvSpPr>
          <p:spPr>
            <a:xfrm>
              <a:off x="2409414" y="2763401"/>
              <a:ext cx="2044018" cy="25828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grpSp>
        <p:nvGrpSpPr>
          <p:cNvPr id="71" name="그룹 70"/>
          <p:cNvGrpSpPr/>
          <p:nvPr/>
        </p:nvGrpSpPr>
        <p:grpSpPr>
          <a:xfrm>
            <a:off x="2043321" y="3080728"/>
            <a:ext cx="2417729" cy="258286"/>
            <a:chOff x="2043321" y="3064349"/>
            <a:chExt cx="2417729" cy="258286"/>
          </a:xfrm>
        </p:grpSpPr>
        <p:sp>
          <p:nvSpPr>
            <p:cNvPr id="72" name="TextBox 71"/>
            <p:cNvSpPr txBox="1"/>
            <p:nvPr/>
          </p:nvSpPr>
          <p:spPr>
            <a:xfrm>
              <a:off x="2043321" y="3131937"/>
              <a:ext cx="26930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EEA1</a:t>
              </a:r>
              <a:endParaRPr lang="en-US" sz="800" b="1" dirty="0">
                <a:latin typeface="Arial"/>
                <a:cs typeface="Arial"/>
              </a:endParaRPr>
            </a:p>
          </p:txBody>
        </p:sp>
        <p:pic>
          <p:nvPicPr>
            <p:cNvPr id="73" name="그림 7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55" t="21855" r="36502" b="63063"/>
            <a:stretch/>
          </p:blipFill>
          <p:spPr>
            <a:xfrm>
              <a:off x="2414748" y="3067064"/>
              <a:ext cx="2046302" cy="252856"/>
            </a:xfrm>
            <a:prstGeom prst="rect">
              <a:avLst/>
            </a:prstGeom>
          </p:spPr>
        </p:pic>
        <p:sp>
          <p:nvSpPr>
            <p:cNvPr id="74" name="Rectangle 12"/>
            <p:cNvSpPr/>
            <p:nvPr/>
          </p:nvSpPr>
          <p:spPr>
            <a:xfrm>
              <a:off x="2409414" y="3064349"/>
              <a:ext cx="2045673" cy="25828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grpSp>
        <p:nvGrpSpPr>
          <p:cNvPr id="75" name="그룹 74"/>
          <p:cNvGrpSpPr/>
          <p:nvPr/>
        </p:nvGrpSpPr>
        <p:grpSpPr>
          <a:xfrm>
            <a:off x="2011511" y="3389643"/>
            <a:ext cx="2441922" cy="258286"/>
            <a:chOff x="2011511" y="3708867"/>
            <a:chExt cx="2441922" cy="258286"/>
          </a:xfrm>
        </p:grpSpPr>
        <p:sp>
          <p:nvSpPr>
            <p:cNvPr id="76" name="TextBox 75"/>
            <p:cNvSpPr txBox="1"/>
            <p:nvPr/>
          </p:nvSpPr>
          <p:spPr>
            <a:xfrm>
              <a:off x="2011511" y="3776455"/>
              <a:ext cx="30296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GOPC</a:t>
              </a:r>
              <a:endParaRPr lang="en-US" sz="800" b="1" dirty="0">
                <a:latin typeface="Arial"/>
                <a:cs typeface="Arial"/>
              </a:endParaRPr>
            </a:p>
          </p:txBody>
        </p:sp>
        <p:pic>
          <p:nvPicPr>
            <p:cNvPr id="77" name="그림 7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7" t="54742" r="27329" b="32603"/>
            <a:stretch/>
          </p:blipFill>
          <p:spPr>
            <a:xfrm>
              <a:off x="2409411" y="3711010"/>
              <a:ext cx="2044021" cy="254000"/>
            </a:xfrm>
            <a:prstGeom prst="rect">
              <a:avLst/>
            </a:prstGeom>
          </p:spPr>
        </p:pic>
        <p:sp>
          <p:nvSpPr>
            <p:cNvPr id="78" name="Rectangle 12"/>
            <p:cNvSpPr/>
            <p:nvPr/>
          </p:nvSpPr>
          <p:spPr>
            <a:xfrm>
              <a:off x="2411266" y="3708867"/>
              <a:ext cx="2042167" cy="25828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grpSp>
        <p:nvGrpSpPr>
          <p:cNvPr id="79" name="그룹 78"/>
          <p:cNvGrpSpPr/>
          <p:nvPr/>
        </p:nvGrpSpPr>
        <p:grpSpPr>
          <a:xfrm>
            <a:off x="2003244" y="3701262"/>
            <a:ext cx="2450190" cy="258286"/>
            <a:chOff x="2003244" y="4015587"/>
            <a:chExt cx="2450190" cy="258286"/>
          </a:xfrm>
        </p:grpSpPr>
        <p:sp>
          <p:nvSpPr>
            <p:cNvPr id="80" name="TextBox 79"/>
            <p:cNvSpPr txBox="1"/>
            <p:nvPr/>
          </p:nvSpPr>
          <p:spPr>
            <a:xfrm>
              <a:off x="2003244" y="4083175"/>
              <a:ext cx="309380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r"/>
              <a:r>
                <a:rPr lang="en-US" sz="800" b="1" dirty="0" smtClean="0">
                  <a:latin typeface="Arial"/>
                  <a:cs typeface="Arial"/>
                </a:rPr>
                <a:t>Hsp90</a:t>
              </a:r>
              <a:endParaRPr lang="en-US" sz="800" b="1" dirty="0">
                <a:latin typeface="Arial"/>
                <a:cs typeface="Arial"/>
              </a:endParaRPr>
            </a:p>
          </p:txBody>
        </p:sp>
        <p:pic>
          <p:nvPicPr>
            <p:cNvPr id="81" name="그림 8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71" t="37542" r="34224" b="39358"/>
            <a:stretch/>
          </p:blipFill>
          <p:spPr>
            <a:xfrm>
              <a:off x="2407127" y="4019027"/>
              <a:ext cx="2046303" cy="251407"/>
            </a:xfrm>
            <a:prstGeom prst="rect">
              <a:avLst/>
            </a:prstGeom>
          </p:spPr>
        </p:pic>
        <p:sp>
          <p:nvSpPr>
            <p:cNvPr id="82" name="Rectangle 12"/>
            <p:cNvSpPr/>
            <p:nvPr/>
          </p:nvSpPr>
          <p:spPr>
            <a:xfrm>
              <a:off x="2409411" y="4015587"/>
              <a:ext cx="2044023" cy="25828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cxnSp>
        <p:nvCxnSpPr>
          <p:cNvPr id="83" name="직선 연결선 178"/>
          <p:cNvCxnSpPr/>
          <p:nvPr/>
        </p:nvCxnSpPr>
        <p:spPr>
          <a:xfrm>
            <a:off x="3532190" y="2098568"/>
            <a:ext cx="889494" cy="1695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178"/>
          <p:cNvCxnSpPr/>
          <p:nvPr/>
        </p:nvCxnSpPr>
        <p:spPr>
          <a:xfrm>
            <a:off x="2536421" y="2091806"/>
            <a:ext cx="889494" cy="1695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20"/>
          <p:cNvSpPr txBox="1"/>
          <p:nvPr/>
        </p:nvSpPr>
        <p:spPr>
          <a:xfrm>
            <a:off x="1793747" y="4275948"/>
            <a:ext cx="106069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/>
                <a:cs typeface="Arial"/>
              </a:rPr>
              <a:t>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86" name="TextBox 19"/>
          <p:cNvSpPr txBox="1"/>
          <p:nvPr/>
        </p:nvSpPr>
        <p:spPr>
          <a:xfrm>
            <a:off x="1793747" y="1717831"/>
            <a:ext cx="9938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a</a:t>
            </a:r>
            <a:endParaRPr lang="en-US" sz="1400" b="1" dirty="0">
              <a:latin typeface="Arial"/>
              <a:cs typeface="Arial"/>
            </a:endParaRPr>
          </a:p>
        </p:txBody>
      </p:sp>
      <p:graphicFrame>
        <p:nvGraphicFramePr>
          <p:cNvPr id="87" name="차트 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3027166"/>
              </p:ext>
            </p:extLst>
          </p:nvPr>
        </p:nvGraphicFramePr>
        <p:xfrm>
          <a:off x="2466498" y="4275948"/>
          <a:ext cx="1788185" cy="19285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8" name="TextBox 87"/>
          <p:cNvSpPr txBox="1"/>
          <p:nvPr/>
        </p:nvSpPr>
        <p:spPr>
          <a:xfrm rot="16200000">
            <a:off x="1530361" y="5098380"/>
            <a:ext cx="16337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b35 membrane localization</a:t>
            </a:r>
          </a:p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rbitrary unit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431955" y="5002920"/>
            <a:ext cx="49694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 rot="18849309">
            <a:off x="2829749" y="6180654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18849309">
            <a:off x="3223365" y="6158585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8849309">
            <a:off x="3693976" y="6158586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72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016681" y="2219283"/>
            <a:ext cx="30937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Rab35</a:t>
            </a:r>
            <a:endParaRPr lang="en-US" sz="800" b="1" dirty="0">
              <a:latin typeface="Arial"/>
              <a:cs typeface="Arial"/>
            </a:endParaRPr>
          </a:p>
        </p:txBody>
      </p:sp>
      <p:cxnSp>
        <p:nvCxnSpPr>
          <p:cNvPr id="94" name="직선 연결선 178"/>
          <p:cNvCxnSpPr/>
          <p:nvPr/>
        </p:nvCxnSpPr>
        <p:spPr>
          <a:xfrm>
            <a:off x="2919365" y="6440939"/>
            <a:ext cx="1074874" cy="11692"/>
          </a:xfrm>
          <a:prstGeom prst="line">
            <a:avLst/>
          </a:prstGeom>
          <a:ln w="317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3271303" y="6520311"/>
            <a:ext cx="309379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Rab35</a:t>
            </a:r>
            <a:endParaRPr lang="en-US" sz="8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69070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A4 용지(210x297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2</cp:revision>
  <dcterms:created xsi:type="dcterms:W3CDTF">2018-01-05T11:15:39Z</dcterms:created>
  <dcterms:modified xsi:type="dcterms:W3CDTF">2018-01-05T13:14:15Z</dcterms:modified>
</cp:coreProperties>
</file>